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314" r:id="rId2"/>
    <p:sldId id="281" r:id="rId3"/>
    <p:sldId id="311" r:id="rId4"/>
    <p:sldId id="280" r:id="rId5"/>
  </p:sldIdLst>
  <p:sldSz cx="6858000" cy="9906000" type="A4"/>
  <p:notesSz cx="9926638" cy="66690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4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k Stoneley" initials="MS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DADAD"/>
    <a:srgbClr val="EBB34D"/>
    <a:srgbClr val="BFBFBF"/>
    <a:srgbClr val="CCCCFF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65"/>
    <p:restoredTop sz="94563"/>
  </p:normalViewPr>
  <p:slideViewPr>
    <p:cSldViewPr snapToGrid="0">
      <p:cViewPr varScale="1">
        <p:scale>
          <a:sx n="108" d="100"/>
          <a:sy n="108" d="100"/>
        </p:scale>
        <p:origin x="3624" y="208"/>
      </p:cViewPr>
      <p:guideLst>
        <p:guide orient="horz" pos="44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ms63\Documents\David's%20paper\oligo(dT)%20qPCR%20Supplementary%20figure%20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ja411\Desktop\qPCRs\RBP%20Final\RBP_A_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0CF-6248-A6C7-9F45DD19CCB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30CF-6248-A6C7-9F45DD19CCB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30CF-6248-A6C7-9F45DD19CCBC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30CF-6248-A6C7-9F45DD19CCBC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30CF-6248-A6C7-9F45DD19CCBC}"/>
              </c:ext>
            </c:extLst>
          </c:dPt>
          <c:dPt>
            <c:idx val="8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30CF-6248-A6C7-9F45DD19CCBC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30CF-6248-A6C7-9F45DD19CCB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G$2:$G$12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2.2175398584671816E-3</c:v>
                  </c:pt>
                  <c:pt idx="2">
                    <c:v>0</c:v>
                  </c:pt>
                  <c:pt idx="3">
                    <c:v>3.4980459745430166E-3</c:v>
                  </c:pt>
                  <c:pt idx="4">
                    <c:v>0</c:v>
                  </c:pt>
                  <c:pt idx="5">
                    <c:v>3.7973730488068589E-3</c:v>
                  </c:pt>
                  <c:pt idx="7">
                    <c:v>0</c:v>
                  </c:pt>
                  <c:pt idx="8">
                    <c:v>9.7453988646361372E-2</c:v>
                  </c:pt>
                  <c:pt idx="9">
                    <c:v>0</c:v>
                  </c:pt>
                  <c:pt idx="10">
                    <c:v>0.149095068204751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A$2:$A$12</c:f>
              <c:numCache>
                <c:formatCode>General</c:formatCode>
                <c:ptCount val="11"/>
              </c:numCache>
            </c:numRef>
          </c:cat>
          <c:val>
            <c:numRef>
              <c:f>Sheet1!$F$2:$F$12</c:f>
              <c:numCache>
                <c:formatCode>General</c:formatCode>
                <c:ptCount val="11"/>
                <c:pt idx="0">
                  <c:v>1</c:v>
                </c:pt>
                <c:pt idx="1">
                  <c:v>1.9352812775399618E-3</c:v>
                </c:pt>
                <c:pt idx="2">
                  <c:v>1</c:v>
                </c:pt>
                <c:pt idx="3">
                  <c:v>8.3944849845892702E-3</c:v>
                </c:pt>
                <c:pt idx="4">
                  <c:v>1</c:v>
                </c:pt>
                <c:pt idx="5">
                  <c:v>8.4773633179946687E-3</c:v>
                </c:pt>
                <c:pt idx="7">
                  <c:v>1</c:v>
                </c:pt>
                <c:pt idx="8">
                  <c:v>0.61451892772946948</c:v>
                </c:pt>
                <c:pt idx="9">
                  <c:v>1</c:v>
                </c:pt>
                <c:pt idx="10">
                  <c:v>0.6158254894853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30CF-6248-A6C7-9F45DD19CC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457984"/>
        <c:axId val="110459520"/>
      </c:barChart>
      <c:catAx>
        <c:axId val="110457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/>
            </a:pPr>
            <a:endParaRPr lang="en-US"/>
          </a:p>
        </c:txPr>
        <c:crossAx val="110459520"/>
        <c:crosses val="autoZero"/>
        <c:auto val="1"/>
        <c:lblAlgn val="ctr"/>
        <c:lblOffset val="100"/>
        <c:noMultiLvlLbl val="0"/>
      </c:catAx>
      <c:valAx>
        <c:axId val="110459520"/>
        <c:scaling>
          <c:orientation val="minMax"/>
          <c:max val="1.100000000000000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9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RNA Fold Change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1045798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nal!$C$24</c:f>
              <c:strCache>
                <c:ptCount val="1"/>
                <c:pt idx="0">
                  <c:v>GAPDH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nal!$H$10:$H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0698614365958437</c:v>
                  </c:pt>
                  <c:pt idx="2">
                    <c:v>1.7141405264624807E-2</c:v>
                  </c:pt>
                  <c:pt idx="3">
                    <c:v>1.1540900313657083E-2</c:v>
                  </c:pt>
                  <c:pt idx="4">
                    <c:v>4.2056536204334721E-3</c:v>
                  </c:pt>
                </c:numCache>
              </c:numRef>
            </c:plus>
            <c:minus>
              <c:numRef>
                <c:f>Final!$H$10:$H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0698614365958437</c:v>
                  </c:pt>
                  <c:pt idx="2">
                    <c:v>1.7141405264624807E-2</c:v>
                  </c:pt>
                  <c:pt idx="3">
                    <c:v>1.1540900313657083E-2</c:v>
                  </c:pt>
                  <c:pt idx="4">
                    <c:v>4.205653620433472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!$B$25:$B$29</c:f>
              <c:strCache>
                <c:ptCount val="5"/>
                <c:pt idx="0">
                  <c:v>Input</c:v>
                </c:pt>
                <c:pt idx="1">
                  <c:v>RIC_A</c:v>
                </c:pt>
                <c:pt idx="2">
                  <c:v>Unbound_A</c:v>
                </c:pt>
                <c:pt idx="3">
                  <c:v>RIC_B</c:v>
                </c:pt>
                <c:pt idx="4">
                  <c:v>Unbound_B</c:v>
                </c:pt>
              </c:strCache>
            </c:strRef>
          </c:cat>
          <c:val>
            <c:numRef>
              <c:f>Final!$C$25:$C$29</c:f>
              <c:numCache>
                <c:formatCode>General</c:formatCode>
                <c:ptCount val="5"/>
                <c:pt idx="0">
                  <c:v>1</c:v>
                </c:pt>
                <c:pt idx="1">
                  <c:v>1.753927291389628</c:v>
                </c:pt>
                <c:pt idx="2">
                  <c:v>2.3275243544504293E-2</c:v>
                </c:pt>
                <c:pt idx="3">
                  <c:v>0.10605993111717744</c:v>
                </c:pt>
                <c:pt idx="4">
                  <c:v>1.21655156498837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3A-0640-921A-6385220BB75B}"/>
            </c:ext>
          </c:extLst>
        </c:ser>
        <c:ser>
          <c:idx val="1"/>
          <c:order val="1"/>
          <c:tx>
            <c:strRef>
              <c:f>Final!$D$24</c:f>
              <c:strCache>
                <c:ptCount val="1"/>
                <c:pt idx="0">
                  <c:v>18S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nal!$H$3:$H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884998656070399E-2</c:v>
                  </c:pt>
                  <c:pt idx="2">
                    <c:v>0.16773212537580662</c:v>
                  </c:pt>
                  <c:pt idx="3">
                    <c:v>8.0667939124366358E-3</c:v>
                  </c:pt>
                  <c:pt idx="4">
                    <c:v>0.26869998024580583</c:v>
                  </c:pt>
                </c:numCache>
              </c:numRef>
            </c:plus>
            <c:minus>
              <c:numRef>
                <c:f>Final!$H$3:$H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884998656070399E-2</c:v>
                  </c:pt>
                  <c:pt idx="2">
                    <c:v>0.16773212537580662</c:v>
                  </c:pt>
                  <c:pt idx="3">
                    <c:v>8.0667939124366358E-3</c:v>
                  </c:pt>
                  <c:pt idx="4">
                    <c:v>0.268699980245805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!$B$25:$B$29</c:f>
              <c:strCache>
                <c:ptCount val="5"/>
                <c:pt idx="0">
                  <c:v>Input</c:v>
                </c:pt>
                <c:pt idx="1">
                  <c:v>RIC_A</c:v>
                </c:pt>
                <c:pt idx="2">
                  <c:v>Unbound_A</c:v>
                </c:pt>
                <c:pt idx="3">
                  <c:v>RIC_B</c:v>
                </c:pt>
                <c:pt idx="4">
                  <c:v>Unbound_B</c:v>
                </c:pt>
              </c:strCache>
            </c:strRef>
          </c:cat>
          <c:val>
            <c:numRef>
              <c:f>Final!$D$25:$D$29</c:f>
              <c:numCache>
                <c:formatCode>General</c:formatCode>
                <c:ptCount val="5"/>
                <c:pt idx="0">
                  <c:v>1</c:v>
                </c:pt>
                <c:pt idx="1">
                  <c:v>0.14068152677791992</c:v>
                </c:pt>
                <c:pt idx="2">
                  <c:v>0.88022406546297882</c:v>
                </c:pt>
                <c:pt idx="3">
                  <c:v>1.997904144448813E-2</c:v>
                </c:pt>
                <c:pt idx="4">
                  <c:v>1.126203943163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3A-0640-921A-6385220BB75B}"/>
            </c:ext>
          </c:extLst>
        </c:ser>
        <c:ser>
          <c:idx val="2"/>
          <c:order val="2"/>
          <c:tx>
            <c:strRef>
              <c:f>Final!$E$24</c:f>
              <c:strCache>
                <c:ptCount val="1"/>
                <c:pt idx="0">
                  <c:v>5.8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nal!$H$15:$H$19</c:f>
                <c:numCache>
                  <c:formatCode>General</c:formatCode>
                  <c:ptCount val="5"/>
                  <c:pt idx="2">
                    <c:v>0</c:v>
                  </c:pt>
                  <c:pt idx="3">
                    <c:v>8.4718479461335344E-2</c:v>
                  </c:pt>
                  <c:pt idx="4">
                    <c:v>0.14901858503856391</c:v>
                  </c:pt>
                </c:numCache>
              </c:numRef>
            </c:plus>
            <c:minus>
              <c:numRef>
                <c:f>Final!$H$15:$H$19</c:f>
                <c:numCache>
                  <c:formatCode>General</c:formatCode>
                  <c:ptCount val="5"/>
                  <c:pt idx="2">
                    <c:v>0</c:v>
                  </c:pt>
                  <c:pt idx="3">
                    <c:v>8.4718479461335344E-2</c:v>
                  </c:pt>
                  <c:pt idx="4">
                    <c:v>0.149018585038563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!$B$25:$B$29</c:f>
              <c:strCache>
                <c:ptCount val="5"/>
                <c:pt idx="0">
                  <c:v>Input</c:v>
                </c:pt>
                <c:pt idx="1">
                  <c:v>RIC_A</c:v>
                </c:pt>
                <c:pt idx="2">
                  <c:v>Unbound_A</c:v>
                </c:pt>
                <c:pt idx="3">
                  <c:v>RIC_B</c:v>
                </c:pt>
                <c:pt idx="4">
                  <c:v>Unbound_B</c:v>
                </c:pt>
              </c:strCache>
            </c:strRef>
          </c:cat>
          <c:val>
            <c:numRef>
              <c:f>Final!$E$25:$E$29</c:f>
              <c:numCache>
                <c:formatCode>General</c:formatCode>
                <c:ptCount val="5"/>
                <c:pt idx="0">
                  <c:v>1</c:v>
                </c:pt>
                <c:pt idx="1">
                  <c:v>0.3336430071598489</c:v>
                </c:pt>
                <c:pt idx="2">
                  <c:v>0.99457776184823332</c:v>
                </c:pt>
                <c:pt idx="3">
                  <c:v>5.2411797025501673E-2</c:v>
                </c:pt>
                <c:pt idx="4">
                  <c:v>1.22837378544196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D3A-0640-921A-6385220BB7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4798104"/>
        <c:axId val="634803024"/>
      </c:barChart>
      <c:catAx>
        <c:axId val="634798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4803024"/>
        <c:crosses val="autoZero"/>
        <c:auto val="1"/>
        <c:lblAlgn val="ctr"/>
        <c:lblOffset val="100"/>
        <c:noMultiLvlLbl val="0"/>
      </c:catAx>
      <c:valAx>
        <c:axId val="6348030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4798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1025296126504549"/>
          <c:y val="7.002260134149893E-2"/>
          <c:w val="0.4038351671397904"/>
          <c:h val="7.81255468066491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3755" y="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4E1776-BE2A-A74E-819C-74EE7F029F47}" type="datetimeFigureOut">
              <a:rPr lang="en-US" smtClean="0"/>
              <a:t>7/2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33526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3755" y="633526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ADAD29-00B4-C647-8870-201927512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2939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755" y="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1DF987-57EF-3649-99CB-73B728648948}" type="datetimeFigureOut">
              <a:rPr lang="en-US" smtClean="0"/>
              <a:t>7/2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84650" y="833438"/>
            <a:ext cx="1557338" cy="2251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428" y="3209226"/>
            <a:ext cx="7941783" cy="262582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33526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755" y="6335260"/>
            <a:ext cx="4300519" cy="3338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2D3A29-B4C0-C346-9121-ED1C44D77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3161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184650" y="833438"/>
            <a:ext cx="1557338" cy="2251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6BFD47-8DFB-4DDB-922C-510E45F0D58F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2640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5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0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76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6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9604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883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739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356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333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1pPr>
            <a:lvl2pPr marL="495285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89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6504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241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599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034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1306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285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BD2B9-B88D-46A5-971E-DE98475C5D3A}" type="datetimeFigureOut">
              <a:rPr lang="en-GB" smtClean="0"/>
              <a:t>27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D68C0-2ECB-440D-82DC-D868CB0407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3410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0570" rtl="0" eaLnBrk="1" latinLnBrk="0" hangingPunct="1"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464" indent="-371464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04838" indent="-309553" algn="l" defTabSz="990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033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67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»"/>
        <a:defRPr sz="2167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26" Type="http://schemas.openxmlformats.org/officeDocument/2006/relationships/image" Target="../media/image27.png"/><Relationship Id="rId3" Type="http://schemas.openxmlformats.org/officeDocument/2006/relationships/image" Target="../media/image4.png"/><Relationship Id="rId21" Type="http://schemas.openxmlformats.org/officeDocument/2006/relationships/image" Target="../media/image22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5" Type="http://schemas.openxmlformats.org/officeDocument/2006/relationships/image" Target="../media/image2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7.png"/><Relationship Id="rId20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24" Type="http://schemas.openxmlformats.org/officeDocument/2006/relationships/image" Target="../media/image25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23" Type="http://schemas.openxmlformats.org/officeDocument/2006/relationships/image" Target="../media/image24.png"/><Relationship Id="rId10" Type="http://schemas.openxmlformats.org/officeDocument/2006/relationships/image" Target="../media/image11.png"/><Relationship Id="rId19" Type="http://schemas.openxmlformats.org/officeDocument/2006/relationships/image" Target="../media/image20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Relationship Id="rId22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gif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2524" y="967500"/>
            <a:ext cx="1041258" cy="21240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89731" y="728817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976903" y="728817"/>
            <a:ext cx="316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283538" y="728817"/>
            <a:ext cx="316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99747" y="72881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++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418061" y="139656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5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257760" y="172961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2/30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418061" y="183630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418061" y="2369264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S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632956" y="959637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34780" y="1565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982766" y="4064920"/>
            <a:ext cx="4678173" cy="2382725"/>
            <a:chOff x="1158728" y="6056671"/>
            <a:chExt cx="4678173" cy="2382725"/>
          </a:xfrm>
        </p:grpSpPr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28494823"/>
                </p:ext>
              </p:extLst>
            </p:nvPr>
          </p:nvGraphicFramePr>
          <p:xfrm>
            <a:off x="1158728" y="6056671"/>
            <a:ext cx="3934381" cy="2142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1739290" y="807006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5S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33203" y="8070064"/>
              <a:ext cx="4068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5S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++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16262" y="807006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8S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600343" y="807006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8S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++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875872" y="8070064"/>
              <a:ext cx="4219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.8S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156398" y="8070064"/>
              <a:ext cx="4219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.8S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++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730394" y="807006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ACT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023267" y="807006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ACT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++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296670" y="8070064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GDH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602311" y="8070064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GDH</a:t>
              </a:r>
            </a:p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++</a:t>
              </a:r>
              <a:endParaRPr lang="en-GB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004622" y="8070064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</a:p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IC method</a:t>
              </a: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134620" y="40649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982766" y="728817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IC method</a:t>
            </a:r>
          </a:p>
        </p:txBody>
      </p:sp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2A78997E-763B-0147-80A2-FEAA421D5F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7040002"/>
              </p:ext>
            </p:extLst>
          </p:nvPr>
        </p:nvGraphicFramePr>
        <p:xfrm>
          <a:off x="1393764" y="6799401"/>
          <a:ext cx="359525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3A284B39-E6E9-9940-8178-F324DB565736}"/>
              </a:ext>
            </a:extLst>
          </p:cNvPr>
          <p:cNvSpPr txBox="1"/>
          <p:nvPr/>
        </p:nvSpPr>
        <p:spPr>
          <a:xfrm>
            <a:off x="139385" y="67783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925F545-36D7-4B43-9083-736E83FCB555}"/>
              </a:ext>
            </a:extLst>
          </p:cNvPr>
          <p:cNvSpPr txBox="1"/>
          <p:nvPr/>
        </p:nvSpPr>
        <p:spPr>
          <a:xfrm rot="16200000">
            <a:off x="656153" y="7704299"/>
            <a:ext cx="11544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RNA fold change</a:t>
            </a:r>
          </a:p>
        </p:txBody>
      </p:sp>
    </p:spTree>
    <p:extLst>
      <p:ext uri="{BB962C8B-B14F-4D97-AF65-F5344CB8AC3E}">
        <p14:creationId xmlns:p14="http://schemas.microsoft.com/office/powerpoint/2010/main" val="162146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644831" y="959637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752" y="644576"/>
            <a:ext cx="3390497" cy="319252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24045" y="4248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366" y="4876634"/>
            <a:ext cx="6303268" cy="107965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4045" y="43110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48019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TextBox 330"/>
          <p:cNvSpPr txBox="1"/>
          <p:nvPr/>
        </p:nvSpPr>
        <p:spPr>
          <a:xfrm>
            <a:off x="269897" y="378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269897" y="34627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47" name="TextBox 346"/>
          <p:cNvSpPr txBox="1"/>
          <p:nvPr/>
        </p:nvSpPr>
        <p:spPr>
          <a:xfrm>
            <a:off x="269897" y="65582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902939" y="404359"/>
            <a:ext cx="5052123" cy="8623881"/>
            <a:chOff x="1535980" y="404359"/>
            <a:chExt cx="5052123" cy="8623881"/>
          </a:xfrm>
        </p:grpSpPr>
        <p:pic>
          <p:nvPicPr>
            <p:cNvPr id="28" name="Picture 1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4354" y="639430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17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0820" y="639430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1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4868" y="639430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20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597"/>
            <a:stretch/>
          </p:blipFill>
          <p:spPr bwMode="auto">
            <a:xfrm>
              <a:off x="5508103" y="639430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8" name="TextBox 317"/>
            <p:cNvSpPr txBox="1"/>
            <p:nvPr/>
          </p:nvSpPr>
          <p:spPr>
            <a:xfrm>
              <a:off x="1564834" y="1064014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Doxy</a:t>
              </a:r>
            </a:p>
          </p:txBody>
        </p:sp>
        <p:sp>
          <p:nvSpPr>
            <p:cNvPr id="319" name="TextBox 318"/>
            <p:cNvSpPr txBox="1"/>
            <p:nvPr/>
          </p:nvSpPr>
          <p:spPr>
            <a:xfrm>
              <a:off x="1535980" y="2185587"/>
              <a:ext cx="5341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Doxy</a:t>
              </a:r>
            </a:p>
          </p:txBody>
        </p:sp>
        <p:sp>
          <p:nvSpPr>
            <p:cNvPr id="321" name="TextBox 320"/>
            <p:cNvSpPr txBox="1"/>
            <p:nvPr/>
          </p:nvSpPr>
          <p:spPr>
            <a:xfrm>
              <a:off x="3395595" y="404359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brillarin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4632617" y="404359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5891650" y="40435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4</a:t>
              </a: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2220274" y="404359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ATF-Flag</a:t>
              </a:r>
            </a:p>
          </p:txBody>
        </p:sp>
        <p:pic>
          <p:nvPicPr>
            <p:cNvPr id="36" name="Picture 2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4354" y="1761003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5" name="Rectangle 324"/>
            <p:cNvSpPr/>
            <p:nvPr/>
          </p:nvSpPr>
          <p:spPr>
            <a:xfrm>
              <a:off x="2717475" y="998396"/>
              <a:ext cx="216000" cy="252000"/>
            </a:xfrm>
            <a:prstGeom prst="rect">
              <a:avLst/>
            </a:prstGeom>
            <a:noFill/>
            <a:ln w="317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38" name="Picture 2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0820" y="1761003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5" name="Picture 24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4868" y="1761003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7" name="Picture 26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055"/>
            <a:stretch/>
          </p:blipFill>
          <p:spPr bwMode="auto">
            <a:xfrm>
              <a:off x="5508103" y="1761003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7" name="Rectangle 326"/>
            <p:cNvSpPr/>
            <p:nvPr/>
          </p:nvSpPr>
          <p:spPr>
            <a:xfrm>
              <a:off x="2184319" y="1901837"/>
              <a:ext cx="216000" cy="252000"/>
            </a:xfrm>
            <a:prstGeom prst="rect">
              <a:avLst/>
            </a:prstGeom>
            <a:noFill/>
            <a:ln w="317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50" name="Picture 28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4354" y="3734875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3" name="Picture 29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0820" y="3734875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4" name="Picture 30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4868" y="3734875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6" name="Picture 32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962"/>
            <a:stretch/>
          </p:blipFill>
          <p:spPr bwMode="auto">
            <a:xfrm>
              <a:off x="5508103" y="3734875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0" name="Rectangle 339"/>
            <p:cNvSpPr/>
            <p:nvPr/>
          </p:nvSpPr>
          <p:spPr>
            <a:xfrm>
              <a:off x="2319055" y="3971267"/>
              <a:ext cx="252000" cy="288000"/>
            </a:xfrm>
            <a:prstGeom prst="rect">
              <a:avLst/>
            </a:prstGeom>
            <a:noFill/>
            <a:ln w="317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55" name="Picture 34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4354" y="4856448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6" name="Picture 35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0820" y="4856448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36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4868" y="4856448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8" name="Picture 37"/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6" t="29296" r="-1"/>
            <a:stretch/>
          </p:blipFill>
          <p:spPr bwMode="auto">
            <a:xfrm>
              <a:off x="5508103" y="4856448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2" name="Rectangle 341"/>
            <p:cNvSpPr/>
            <p:nvPr/>
          </p:nvSpPr>
          <p:spPr>
            <a:xfrm>
              <a:off x="2187393" y="5279974"/>
              <a:ext cx="252000" cy="288000"/>
            </a:xfrm>
            <a:prstGeom prst="rect">
              <a:avLst/>
            </a:prstGeom>
            <a:noFill/>
            <a:ln w="317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3" name="TextBox 342"/>
            <p:cNvSpPr txBox="1"/>
            <p:nvPr/>
          </p:nvSpPr>
          <p:spPr>
            <a:xfrm>
              <a:off x="3395595" y="3508923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brillarin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TextBox 343"/>
            <p:cNvSpPr txBox="1"/>
            <p:nvPr/>
          </p:nvSpPr>
          <p:spPr>
            <a:xfrm>
              <a:off x="4632617" y="3508923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345" name="TextBox 344"/>
            <p:cNvSpPr txBox="1"/>
            <p:nvPr/>
          </p:nvSpPr>
          <p:spPr>
            <a:xfrm>
              <a:off x="5891650" y="350892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4</a:t>
              </a:r>
            </a:p>
          </p:txBody>
        </p:sp>
        <p:sp>
          <p:nvSpPr>
            <p:cNvPr id="346" name="TextBox 345"/>
            <p:cNvSpPr txBox="1"/>
            <p:nvPr/>
          </p:nvSpPr>
          <p:spPr>
            <a:xfrm>
              <a:off x="2194627" y="3508923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AP26-Flag</a:t>
              </a:r>
            </a:p>
          </p:txBody>
        </p:sp>
        <p:sp>
          <p:nvSpPr>
            <p:cNvPr id="348" name="TextBox 347"/>
            <p:cNvSpPr txBox="1"/>
            <p:nvPr/>
          </p:nvSpPr>
          <p:spPr>
            <a:xfrm>
              <a:off x="1564834" y="4159459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Doxy</a:t>
              </a:r>
            </a:p>
          </p:txBody>
        </p:sp>
        <p:sp>
          <p:nvSpPr>
            <p:cNvPr id="349" name="TextBox 348"/>
            <p:cNvSpPr txBox="1"/>
            <p:nvPr/>
          </p:nvSpPr>
          <p:spPr>
            <a:xfrm>
              <a:off x="1535980" y="5281032"/>
              <a:ext cx="5341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Doxy</a:t>
              </a: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535980" y="6600715"/>
              <a:ext cx="5052123" cy="2427525"/>
              <a:chOff x="1263507" y="7177673"/>
              <a:chExt cx="5052123" cy="2427525"/>
            </a:xfrm>
          </p:grpSpPr>
          <p:pic>
            <p:nvPicPr>
              <p:cNvPr id="1063" name="Picture 39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1881" y="7403625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0" name="Picture 40"/>
              <p:cNvPicPr>
                <a:picLocks noChangeAspect="1" noChangeArrowheads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8347" y="7403625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3" name="Picture 41"/>
              <p:cNvPicPr>
                <a:picLocks noChangeAspect="1"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82395" y="7403625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0" name="Picture 44"/>
              <p:cNvPicPr>
                <a:picLocks noChangeAspect="1" noChangeArrowheads="1"/>
              </p:cNvPicPr>
              <p:nvPr/>
            </p:nvPicPr>
            <p:blipFill rotWithShape="1"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91" t="23572"/>
              <a:stretch/>
            </p:blipFill>
            <p:spPr bwMode="auto">
              <a:xfrm>
                <a:off x="5235630" y="7403625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51" name="Rectangle 350"/>
              <p:cNvSpPr/>
              <p:nvPr/>
            </p:nvSpPr>
            <p:spPr>
              <a:xfrm>
                <a:off x="2250352" y="7779127"/>
                <a:ext cx="252000" cy="288000"/>
              </a:xfrm>
              <a:prstGeom prst="rect">
                <a:avLst/>
              </a:prstGeom>
              <a:noFill/>
              <a:ln w="3175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75" name="Picture 46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1881" y="8525198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59" name="TextBox 358"/>
              <p:cNvSpPr txBox="1"/>
              <p:nvPr/>
            </p:nvSpPr>
            <p:spPr>
              <a:xfrm>
                <a:off x="1292361" y="7828209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Doxy</a:t>
                </a:r>
              </a:p>
            </p:txBody>
          </p:sp>
          <p:sp>
            <p:nvSpPr>
              <p:cNvPr id="360" name="TextBox 359"/>
              <p:cNvSpPr txBox="1"/>
              <p:nvPr/>
            </p:nvSpPr>
            <p:spPr>
              <a:xfrm>
                <a:off x="1263507" y="8949782"/>
                <a:ext cx="53412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Doxy</a:t>
                </a:r>
              </a:p>
            </p:txBody>
          </p:sp>
          <p:pic>
            <p:nvPicPr>
              <p:cNvPr id="76" name="Picture 47"/>
              <p:cNvPicPr>
                <a:picLocks noChangeAspect="1" noChangeArrowheads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8347" y="8525198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7" name="Picture 48"/>
              <p:cNvPicPr>
                <a:picLocks noChangeAspect="1" noChangeArrowheads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82395" y="8525198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8" name="Picture 49"/>
              <p:cNvPicPr>
                <a:picLocks noChangeAspect="1" noChangeArrowheads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00" t="27711"/>
              <a:stretch/>
            </p:blipFill>
            <p:spPr bwMode="auto">
              <a:xfrm>
                <a:off x="5235630" y="8525198"/>
                <a:ext cx="1080000" cy="10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64" name="Rectangle 363"/>
              <p:cNvSpPr/>
              <p:nvPr/>
            </p:nvSpPr>
            <p:spPr>
              <a:xfrm>
                <a:off x="2489655" y="9304498"/>
                <a:ext cx="259200" cy="288000"/>
              </a:xfrm>
              <a:prstGeom prst="rect">
                <a:avLst/>
              </a:prstGeom>
              <a:noFill/>
              <a:ln w="3175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65" name="TextBox 364"/>
              <p:cNvSpPr txBox="1"/>
              <p:nvPr/>
            </p:nvSpPr>
            <p:spPr>
              <a:xfrm>
                <a:off x="3123122" y="7177673"/>
                <a:ext cx="7104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brillarin</a:t>
                </a:r>
                <a:endParaRPr lang="en-GB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4360144" y="7177673"/>
                <a:ext cx="5245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rge</a:t>
                </a:r>
              </a:p>
            </p:txBody>
          </p:sp>
          <p:sp>
            <p:nvSpPr>
              <p:cNvPr id="367" name="TextBox 366"/>
              <p:cNvSpPr txBox="1"/>
              <p:nvPr/>
            </p:nvSpPr>
            <p:spPr>
              <a:xfrm>
                <a:off x="5619177" y="7177673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4</a:t>
                </a: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1922154" y="7177673"/>
                <a:ext cx="8002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GDN-Flag</a:t>
                </a:r>
              </a:p>
            </p:txBody>
          </p:sp>
        </p:grpSp>
      </p:grpSp>
      <p:sp>
        <p:nvSpPr>
          <p:cNvPr id="370" name="TextBox 369"/>
          <p:cNvSpPr txBox="1"/>
          <p:nvPr/>
        </p:nvSpPr>
        <p:spPr>
          <a:xfrm>
            <a:off x="4626317" y="9580273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4221586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28442" y="9580205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81539" y="513274"/>
            <a:ext cx="336952" cy="2757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i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714850" y="531110"/>
            <a:ext cx="378630" cy="2757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ii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oup 50"/>
          <p:cNvGrpSpPr/>
          <p:nvPr/>
        </p:nvGrpSpPr>
        <p:grpSpPr>
          <a:xfrm>
            <a:off x="1118100" y="938397"/>
            <a:ext cx="1959544" cy="2518765"/>
            <a:chOff x="1001507" y="938397"/>
            <a:chExt cx="1959544" cy="2518765"/>
          </a:xfrm>
        </p:grpSpPr>
        <p:pic>
          <p:nvPicPr>
            <p:cNvPr id="18" name="Picture 4"/>
            <p:cNvPicPr>
              <a:picLocks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7" t="30934"/>
            <a:stretch/>
          </p:blipFill>
          <p:spPr bwMode="auto">
            <a:xfrm>
              <a:off x="1460664" y="1436913"/>
              <a:ext cx="1500387" cy="18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2516313" y="2883499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****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001507" y="3052720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X5461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48984" y="3226330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D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547710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52690" y="321094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01737" y="321094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261731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93514" y="3052720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20140" y="322633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504858" y="3226330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16890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737709" y="2157415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176820" y="2883499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****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826864" y="2694103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****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858838" y="938397"/>
              <a:ext cx="7040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re-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268658" y="141866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172478" y="217745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268658" y="292362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4112271" y="938397"/>
            <a:ext cx="1964190" cy="2523789"/>
            <a:chOff x="4285682" y="938397"/>
            <a:chExt cx="1964190" cy="2523789"/>
          </a:xfrm>
        </p:grpSpPr>
        <p:sp>
          <p:nvSpPr>
            <p:cNvPr id="28" name="TextBox 27"/>
            <p:cNvSpPr txBox="1"/>
            <p:nvPr/>
          </p:nvSpPr>
          <p:spPr>
            <a:xfrm>
              <a:off x="5786814" y="2763063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****</a:t>
              </a:r>
            </a:p>
          </p:txBody>
        </p:sp>
        <p:pic>
          <p:nvPicPr>
            <p:cNvPr id="30" name="Picture 5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89" t="28926"/>
            <a:stretch/>
          </p:blipFill>
          <p:spPr bwMode="auto">
            <a:xfrm>
              <a:off x="4739425" y="1436913"/>
              <a:ext cx="1510447" cy="18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TextBox 30"/>
            <p:cNvSpPr txBox="1"/>
            <p:nvPr/>
          </p:nvSpPr>
          <p:spPr>
            <a:xfrm>
              <a:off x="4285682" y="3057744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X546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433159" y="3231354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D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841668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842510" y="321094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195695" y="321094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547413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184416" y="3052720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506904" y="322633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799898" y="3226330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902572" y="304502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4012239" y="2184464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043243" y="938397"/>
              <a:ext cx="9028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mRNA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570795" y="14636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474615" y="2195867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570795" y="291390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2406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22</TotalTime>
  <Words>131</Words>
  <Application>Microsoft Macintosh PowerPoint</Application>
  <PresentationFormat>A4 Paper (210x297 mm)</PresentationFormat>
  <Paragraphs>100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Del Rio Pineiro</dc:creator>
  <cp:lastModifiedBy>Anne Willis</cp:lastModifiedBy>
  <cp:revision>396</cp:revision>
  <cp:lastPrinted>2018-04-18T13:17:31Z</cp:lastPrinted>
  <dcterms:created xsi:type="dcterms:W3CDTF">2017-02-14T12:06:43Z</dcterms:created>
  <dcterms:modified xsi:type="dcterms:W3CDTF">2018-07-27T10:06:10Z</dcterms:modified>
</cp:coreProperties>
</file>